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5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386351706036746"/>
          <c:y val="1.9837759250681899E-2"/>
          <c:w val="0.83597581552305966"/>
          <c:h val="0.93922816633214967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着粒数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着粒数!$E$3:$E$32</c:f>
              <c:numCache>
                <c:formatCode>0.00_ </c:formatCode>
                <c:ptCount val="30"/>
                <c:pt idx="0">
                  <c:v>200.54152937646782</c:v>
                </c:pt>
                <c:pt idx="1">
                  <c:v>201.09924078526265</c:v>
                </c:pt>
                <c:pt idx="2">
                  <c:v>208.73528379304935</c:v>
                </c:pt>
                <c:pt idx="3">
                  <c:v>208.6524625596584</c:v>
                </c:pt>
                <c:pt idx="4">
                  <c:v>191.29169634245747</c:v>
                </c:pt>
                <c:pt idx="5">
                  <c:v>204.63174368439141</c:v>
                </c:pt>
                <c:pt idx="6">
                  <c:v>187.49953030884967</c:v>
                </c:pt>
                <c:pt idx="7">
                  <c:v>189.01110723858861</c:v>
                </c:pt>
                <c:pt idx="8">
                  <c:v>182.99359889963566</c:v>
                </c:pt>
                <c:pt idx="9">
                  <c:v>183.31591695501734</c:v>
                </c:pt>
                <c:pt idx="10">
                  <c:v>194.69142147542371</c:v>
                </c:pt>
                <c:pt idx="11">
                  <c:v>184.74957506327283</c:v>
                </c:pt>
                <c:pt idx="12">
                  <c:v>202.88990977209582</c:v>
                </c:pt>
                <c:pt idx="13">
                  <c:v>190.96238818113522</c:v>
                </c:pt>
                <c:pt idx="14">
                  <c:v>195.39647146200332</c:v>
                </c:pt>
                <c:pt idx="15">
                  <c:v>207.72456506907722</c:v>
                </c:pt>
                <c:pt idx="16">
                  <c:v>201.71446728784565</c:v>
                </c:pt>
                <c:pt idx="17">
                  <c:v>202.41473002356318</c:v>
                </c:pt>
                <c:pt idx="18">
                  <c:v>203.11505140123052</c:v>
                </c:pt>
                <c:pt idx="19">
                  <c:v>207.53420541854493</c:v>
                </c:pt>
                <c:pt idx="20">
                  <c:v>197.13016588118333</c:v>
                </c:pt>
                <c:pt idx="21">
                  <c:v>215.60218161257936</c:v>
                </c:pt>
                <c:pt idx="22">
                  <c:v>194.59928140997147</c:v>
                </c:pt>
                <c:pt idx="23">
                  <c:v>197.96450391793482</c:v>
                </c:pt>
                <c:pt idx="24">
                  <c:v>199.93167852607385</c:v>
                </c:pt>
                <c:pt idx="25">
                  <c:v>211.14578144959765</c:v>
                </c:pt>
                <c:pt idx="26">
                  <c:v>197.31580556625633</c:v>
                </c:pt>
                <c:pt idx="27">
                  <c:v>212.49459404616559</c:v>
                </c:pt>
                <c:pt idx="28">
                  <c:v>214.02200626216464</c:v>
                </c:pt>
                <c:pt idx="29">
                  <c:v>206.8527685181162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着粒数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着粒数!$N$3:$N$32</c:f>
              <c:numCache>
                <c:formatCode>General</c:formatCode>
                <c:ptCount val="30"/>
                <c:pt idx="0">
                  <c:v>189.59956722449658</c:v>
                </c:pt>
                <c:pt idx="1">
                  <c:v>196.29996295289601</c:v>
                </c:pt>
                <c:pt idx="2">
                  <c:v>205.83150267661395</c:v>
                </c:pt>
                <c:pt idx="3">
                  <c:v>207.47714053270374</c:v>
                </c:pt>
                <c:pt idx="4">
                  <c:v>192.48830092431157</c:v>
                </c:pt>
                <c:pt idx="5">
                  <c:v>193.72088529377999</c:v>
                </c:pt>
                <c:pt idx="6">
                  <c:v>195.72186634776085</c:v>
                </c:pt>
                <c:pt idx="7">
                  <c:v>190.55372864657772</c:v>
                </c:pt>
                <c:pt idx="8">
                  <c:v>193.32049266053687</c:v>
                </c:pt>
                <c:pt idx="9">
                  <c:v>182.15763749088069</c:v>
                </c:pt>
                <c:pt idx="10">
                  <c:v>193.75374220146895</c:v>
                </c:pt>
                <c:pt idx="11">
                  <c:v>186.21383941638098</c:v>
                </c:pt>
                <c:pt idx="12">
                  <c:v>200.01105787241178</c:v>
                </c:pt>
                <c:pt idx="13">
                  <c:v>189.6341956276178</c:v>
                </c:pt>
                <c:pt idx="14">
                  <c:v>200.22335906875585</c:v>
                </c:pt>
                <c:pt idx="15">
                  <c:v>221.52386078902305</c:v>
                </c:pt>
                <c:pt idx="16">
                  <c:v>200.56549951314705</c:v>
                </c:pt>
                <c:pt idx="17">
                  <c:v>212.54878006613754</c:v>
                </c:pt>
                <c:pt idx="18">
                  <c:v>198.36355905828086</c:v>
                </c:pt>
                <c:pt idx="19">
                  <c:v>215.34407275211274</c:v>
                </c:pt>
                <c:pt idx="20">
                  <c:v>195.36964187693874</c:v>
                </c:pt>
                <c:pt idx="21">
                  <c:v>205.6208304767886</c:v>
                </c:pt>
                <c:pt idx="22">
                  <c:v>205.45796415229708</c:v>
                </c:pt>
                <c:pt idx="23">
                  <c:v>197.5152188573409</c:v>
                </c:pt>
                <c:pt idx="24">
                  <c:v>205.96750594729352</c:v>
                </c:pt>
                <c:pt idx="25">
                  <c:v>220.37148477028907</c:v>
                </c:pt>
                <c:pt idx="26">
                  <c:v>199.32444324412532</c:v>
                </c:pt>
                <c:pt idx="27">
                  <c:v>219.8444931730339</c:v>
                </c:pt>
                <c:pt idx="28">
                  <c:v>217.38421101814481</c:v>
                </c:pt>
                <c:pt idx="29">
                  <c:v>216.338727144086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8980992"/>
        <c:axId val="137049216"/>
      </c:barChart>
      <c:catAx>
        <c:axId val="228980992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37049216"/>
        <c:crosses val="autoZero"/>
        <c:auto val="1"/>
        <c:lblAlgn val="ctr"/>
        <c:lblOffset val="100"/>
        <c:noMultiLvlLbl val="0"/>
      </c:catAx>
      <c:valAx>
        <c:axId val="137049216"/>
        <c:scaling>
          <c:orientation val="minMax"/>
        </c:scaling>
        <c:delete val="0"/>
        <c:axPos val="b"/>
        <c:numFmt formatCode="0.00_ 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289809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6824431"/>
              </p:ext>
            </p:extLst>
          </p:nvPr>
        </p:nvGraphicFramePr>
        <p:xfrm>
          <a:off x="304800" y="381000"/>
          <a:ext cx="5334000" cy="8185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05857" y="8566667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Grain number per panicle</a:t>
            </a:r>
            <a:endParaRPr lang="en-US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257800" y="5332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1</a:t>
            </a:r>
            <a:endParaRPr lang="en-US" sz="800" spc="-10" dirty="0"/>
          </a:p>
        </p:txBody>
      </p:sp>
      <p:sp>
        <p:nvSpPr>
          <p:cNvPr id="95" name="TextBox 94"/>
          <p:cNvSpPr txBox="1"/>
          <p:nvPr/>
        </p:nvSpPr>
        <p:spPr>
          <a:xfrm>
            <a:off x="5257800" y="7904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37</a:t>
            </a:r>
            <a:endParaRPr lang="en-US" sz="800" spc="-10" dirty="0"/>
          </a:p>
        </p:txBody>
      </p:sp>
      <p:sp>
        <p:nvSpPr>
          <p:cNvPr id="96" name="TextBox 95"/>
          <p:cNvSpPr txBox="1"/>
          <p:nvPr/>
        </p:nvSpPr>
        <p:spPr>
          <a:xfrm>
            <a:off x="5257800" y="10477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97" name="TextBox 96"/>
          <p:cNvSpPr txBox="1"/>
          <p:nvPr/>
        </p:nvSpPr>
        <p:spPr>
          <a:xfrm>
            <a:off x="5257800" y="13050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6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49</a:t>
            </a:r>
            <a:endParaRPr lang="en-US" sz="800" spc="-10" dirty="0"/>
          </a:p>
        </p:txBody>
      </p:sp>
      <p:sp>
        <p:nvSpPr>
          <p:cNvPr id="98" name="TextBox 97"/>
          <p:cNvSpPr txBox="1"/>
          <p:nvPr/>
        </p:nvSpPr>
        <p:spPr>
          <a:xfrm>
            <a:off x="5257800" y="15623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4</a:t>
            </a:r>
            <a:endParaRPr lang="en-US" sz="800" spc="-10" dirty="0"/>
          </a:p>
        </p:txBody>
      </p:sp>
      <p:sp>
        <p:nvSpPr>
          <p:cNvPr id="99" name="TextBox 98"/>
          <p:cNvSpPr txBox="1"/>
          <p:nvPr/>
        </p:nvSpPr>
        <p:spPr>
          <a:xfrm>
            <a:off x="5257800" y="18195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68</a:t>
            </a:r>
            <a:endParaRPr lang="en-US" sz="800" spc="-10" dirty="0"/>
          </a:p>
        </p:txBody>
      </p:sp>
      <p:sp>
        <p:nvSpPr>
          <p:cNvPr id="100" name="TextBox 99"/>
          <p:cNvSpPr txBox="1"/>
          <p:nvPr/>
        </p:nvSpPr>
        <p:spPr>
          <a:xfrm>
            <a:off x="5257800" y="20768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7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80</a:t>
            </a:r>
            <a:endParaRPr lang="en-US" sz="800" spc="-10" dirty="0"/>
          </a:p>
        </p:txBody>
      </p:sp>
      <p:sp>
        <p:nvSpPr>
          <p:cNvPr id="101" name="TextBox 100"/>
          <p:cNvSpPr txBox="1"/>
          <p:nvPr/>
        </p:nvSpPr>
        <p:spPr>
          <a:xfrm>
            <a:off x="5257800" y="233414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48</a:t>
            </a:r>
            <a:endParaRPr lang="en-US" sz="800" spc="-10" dirty="0"/>
          </a:p>
        </p:txBody>
      </p:sp>
      <p:sp>
        <p:nvSpPr>
          <p:cNvPr id="102" name="TextBox 101"/>
          <p:cNvSpPr txBox="1"/>
          <p:nvPr/>
        </p:nvSpPr>
        <p:spPr>
          <a:xfrm>
            <a:off x="5257800" y="258825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3</a:t>
            </a:r>
            <a:endParaRPr lang="en-US" sz="800" spc="-10" dirty="0"/>
          </a:p>
        </p:txBody>
      </p:sp>
      <p:sp>
        <p:nvSpPr>
          <p:cNvPr id="103" name="TextBox 102"/>
          <p:cNvSpPr txBox="1"/>
          <p:nvPr/>
        </p:nvSpPr>
        <p:spPr>
          <a:xfrm>
            <a:off x="5257800" y="28486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03</a:t>
            </a:r>
            <a:endParaRPr lang="en-US" sz="800" spc="-10" dirty="0"/>
          </a:p>
        </p:txBody>
      </p:sp>
      <p:sp>
        <p:nvSpPr>
          <p:cNvPr id="104" name="TextBox 103"/>
          <p:cNvSpPr txBox="1"/>
          <p:nvPr/>
        </p:nvSpPr>
        <p:spPr>
          <a:xfrm>
            <a:off x="5257800" y="310597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105" name="TextBox 104"/>
          <p:cNvSpPr txBox="1"/>
          <p:nvPr/>
        </p:nvSpPr>
        <p:spPr>
          <a:xfrm>
            <a:off x="5257800" y="33632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22</a:t>
            </a:r>
            <a:endParaRPr lang="en-US" sz="800" spc="-10" dirty="0"/>
          </a:p>
        </p:txBody>
      </p:sp>
      <p:sp>
        <p:nvSpPr>
          <p:cNvPr id="106" name="TextBox 105"/>
          <p:cNvSpPr txBox="1"/>
          <p:nvPr/>
        </p:nvSpPr>
        <p:spPr>
          <a:xfrm>
            <a:off x="5257800" y="362052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3.80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2.57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5257800" y="38699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7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37</a:t>
            </a:r>
            <a:endParaRPr lang="en-US" sz="800" spc="-10" dirty="0"/>
          </a:p>
        </p:txBody>
      </p:sp>
      <p:sp>
        <p:nvSpPr>
          <p:cNvPr id="108" name="TextBox 107"/>
          <p:cNvSpPr txBox="1"/>
          <p:nvPr/>
        </p:nvSpPr>
        <p:spPr>
          <a:xfrm>
            <a:off x="5257800" y="41271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51</a:t>
            </a:r>
            <a:endParaRPr lang="en-US" sz="800" spc="-10" dirty="0"/>
          </a:p>
        </p:txBody>
      </p:sp>
      <p:sp>
        <p:nvSpPr>
          <p:cNvPr id="109" name="TextBox 108"/>
          <p:cNvSpPr txBox="1"/>
          <p:nvPr/>
        </p:nvSpPr>
        <p:spPr>
          <a:xfrm>
            <a:off x="5257800" y="43844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56</a:t>
            </a:r>
            <a:endParaRPr lang="en-US" sz="800" spc="-10" dirty="0"/>
          </a:p>
        </p:txBody>
      </p:sp>
      <p:sp>
        <p:nvSpPr>
          <p:cNvPr id="110" name="TextBox 109"/>
          <p:cNvSpPr txBox="1"/>
          <p:nvPr/>
        </p:nvSpPr>
        <p:spPr>
          <a:xfrm>
            <a:off x="5257800" y="46417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03</a:t>
            </a:r>
            <a:endParaRPr lang="en-US" sz="800" spc="-10" dirty="0"/>
          </a:p>
        </p:txBody>
      </p:sp>
      <p:sp>
        <p:nvSpPr>
          <p:cNvPr id="111" name="TextBox 110"/>
          <p:cNvSpPr txBox="1"/>
          <p:nvPr/>
        </p:nvSpPr>
        <p:spPr>
          <a:xfrm>
            <a:off x="5257800" y="489901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1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21</a:t>
            </a:r>
            <a:endParaRPr lang="en-US" sz="800" spc="-10" dirty="0"/>
          </a:p>
        </p:txBody>
      </p:sp>
      <p:sp>
        <p:nvSpPr>
          <p:cNvPr id="112" name="TextBox 111"/>
          <p:cNvSpPr txBox="1"/>
          <p:nvPr/>
        </p:nvSpPr>
        <p:spPr>
          <a:xfrm>
            <a:off x="5257800" y="515629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6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5.78</a:t>
            </a:r>
            <a:endParaRPr lang="en-US" sz="800" spc="-10" dirty="0"/>
          </a:p>
        </p:txBody>
      </p:sp>
      <p:sp>
        <p:nvSpPr>
          <p:cNvPr id="113" name="TextBox 112"/>
          <p:cNvSpPr txBox="1"/>
          <p:nvPr/>
        </p:nvSpPr>
        <p:spPr>
          <a:xfrm>
            <a:off x="5257800" y="54135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2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76</a:t>
            </a:r>
            <a:endParaRPr lang="en-US" sz="800" spc="-10" dirty="0"/>
          </a:p>
        </p:txBody>
      </p:sp>
      <p:sp>
        <p:nvSpPr>
          <p:cNvPr id="114" name="TextBox 113"/>
          <p:cNvSpPr txBox="1"/>
          <p:nvPr/>
        </p:nvSpPr>
        <p:spPr>
          <a:xfrm>
            <a:off x="5257800" y="56708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1</a:t>
            </a:r>
            <a:endParaRPr lang="en-US" sz="800" spc="-10" dirty="0"/>
          </a:p>
        </p:txBody>
      </p:sp>
      <p:sp>
        <p:nvSpPr>
          <p:cNvPr id="115" name="TextBox 114"/>
          <p:cNvSpPr txBox="1"/>
          <p:nvPr/>
        </p:nvSpPr>
        <p:spPr>
          <a:xfrm>
            <a:off x="5257800" y="592812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39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2.41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5257800" y="644267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1</a:t>
            </a:r>
            <a:endParaRPr lang="en-US" sz="800" spc="-10" dirty="0"/>
          </a:p>
        </p:txBody>
      </p:sp>
      <p:sp>
        <p:nvSpPr>
          <p:cNvPr id="117" name="TextBox 116"/>
          <p:cNvSpPr txBox="1"/>
          <p:nvPr/>
        </p:nvSpPr>
        <p:spPr>
          <a:xfrm>
            <a:off x="5257800" y="66999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09</a:t>
            </a:r>
            <a:endParaRPr lang="en-US" sz="800" spc="-10" dirty="0"/>
          </a:p>
        </p:txBody>
      </p:sp>
      <p:sp>
        <p:nvSpPr>
          <p:cNvPr id="118" name="TextBox 117"/>
          <p:cNvSpPr txBox="1"/>
          <p:nvPr/>
        </p:nvSpPr>
        <p:spPr>
          <a:xfrm>
            <a:off x="5257800" y="69572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6</a:t>
            </a:r>
            <a:endParaRPr lang="en-US" sz="800" spc="-10" dirty="0"/>
          </a:p>
        </p:txBody>
      </p:sp>
      <p:sp>
        <p:nvSpPr>
          <p:cNvPr id="119" name="TextBox 118"/>
          <p:cNvSpPr txBox="1"/>
          <p:nvPr/>
        </p:nvSpPr>
        <p:spPr>
          <a:xfrm>
            <a:off x="5257800" y="72145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120" name="TextBox 119"/>
          <p:cNvSpPr txBox="1"/>
          <p:nvPr/>
        </p:nvSpPr>
        <p:spPr>
          <a:xfrm>
            <a:off x="5257800" y="74717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52</a:t>
            </a:r>
            <a:endParaRPr lang="en-US" sz="800" spc="-10" dirty="0"/>
          </a:p>
        </p:txBody>
      </p:sp>
      <p:sp>
        <p:nvSpPr>
          <p:cNvPr id="121" name="TextBox 120"/>
          <p:cNvSpPr txBox="1"/>
          <p:nvPr/>
        </p:nvSpPr>
        <p:spPr>
          <a:xfrm>
            <a:off x="5257800" y="772905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8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8</a:t>
            </a:r>
            <a:endParaRPr lang="en-US" sz="800" spc="-10" dirty="0"/>
          </a:p>
        </p:txBody>
      </p:sp>
      <p:sp>
        <p:nvSpPr>
          <p:cNvPr id="122" name="TextBox 121"/>
          <p:cNvSpPr txBox="1"/>
          <p:nvPr/>
        </p:nvSpPr>
        <p:spPr>
          <a:xfrm>
            <a:off x="5257800" y="6185396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5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81</a:t>
            </a:r>
            <a:endParaRPr lang="en-US" sz="800" spc="-10" dirty="0"/>
          </a:p>
        </p:txBody>
      </p:sp>
      <p:sp>
        <p:nvSpPr>
          <p:cNvPr id="123" name="TextBox 122"/>
          <p:cNvSpPr txBox="1"/>
          <p:nvPr/>
        </p:nvSpPr>
        <p:spPr>
          <a:xfrm>
            <a:off x="5257800" y="798632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4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3</a:t>
            </a:r>
            <a:endParaRPr lang="en-US" sz="2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099374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089826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7:56Z</dcterms:modified>
</cp:coreProperties>
</file>